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291F12-F201-4364-8630-EFDC4FEB193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E2FAA9-55F4-454D-A6A7-F1F28910AD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317B4-4093-4697-96CB-E31C4EEE7E1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A9D0E7-2194-4D57-BC53-22D6ACF280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97E9A-05F8-4DAD-910F-DFCD8166D4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B9310-E053-4EC2-8955-B59B404BE5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242C90-3C05-4A09-B79E-26E38DB45D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10D0B-F176-47E8-86B1-6BF6A25960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35E977-4B0E-4348-A808-CAC648A8C1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F36B53-A7A1-4155-864C-230B1A4FCC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CEB236-15FB-4BDA-ACE4-101B7ED852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4E9FE5-928A-46B2-823D-A178935700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F8DC37-FDA7-4C98-A8EA-EAD576A72189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Comic Sans M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0"/>
          <p:cNvSpPr/>
          <p:nvPr/>
        </p:nvSpPr>
        <p:spPr>
          <a:xfrm>
            <a:off x="915840" y="584280"/>
            <a:ext cx="8228160" cy="161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TGGATACCGACCAGCACAAAGC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TGCAAACCGCCATGAGCCAGATTGAAAAACAATTCGGCAAAGGCAGCATCATGAAACTCGGCGCCGA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GCAA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TCGACGTCCAGGCCATCAGCACCGGCAGCCTCAGCCTCGACGTCGCCCT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GCGTCGGCGGCATCCCCAAAGGCCGCGTCAC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AATCTACGGCCCCGAATCCGGCGGCAAAACCACCCTCGCCCTGAGCATCATCGCCCAGTCCCAGAAAGCCGGCGGCACCTGCGCCTTTATCGACGCCGAACACGCCCTCGACCCCGTCTACGCCCGCGCCCTGGGTGTGAACACCGATGACCTCCTGGTCTCCCAGCCCGACAACGGCGAGCAGGCCCTGGAAATCATGGAACTGCTGATCCGCTCCGGCGCCATCGACGT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T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T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TGGACTCGGTGGCTGCGCTGACCCCCCGCGC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T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GCGAGATGGGCGACAGCCTCCCGGGGTTGCAGGCCCGGCTGATGAGCCAGGCGCTGCGCAAACTCACCAGCATCGTCTCCAAAACCGGCACCGCCGCGATCTTCATCAACCAGGTGCGCGAGAAGATCGGCGTGATGTACGGCAACCCCGAAACCACCACCGGCGG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GGCCCTGAAGTTCTACGCCTCGGTCCGGTTGGACGT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GCAAGATGGGCGGCAAGTCCACCATGGTCGACAATGTGGC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TGTCGCACAGCGTCAAGGTCAAGACCGTCAAGAACAAGGTCGCGCCGCCGTTCAAGGAAGTGGAGCTGACGCTGCGCTA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G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ACGG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TCGATGC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TGGATGACCTGGTCACGCTCGCCACCACTTTCGAGGTGATCAAGAAGGCTGGGAGCTTCTACAGCTACGGGGACGAACGCATCGGGCAGGGCAAGGAAAAAGCCATTGCCTTCCTGAGTGAGCGTCCGGATCTGCTTGCCGATATCCGCGAGCGTGTGCT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CCCAGATGCGCGGCACCCCTGTCGC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C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X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CTCCCTGAACCCGCCCTCTCTGCCGACTGA</a:t>
            </a:r>
            <a:r>
              <a:rPr b="0" lang="fr-FR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42" name="Text Box 13"/>
          <p:cNvSpPr/>
          <p:nvPr/>
        </p:nvSpPr>
        <p:spPr>
          <a:xfrm>
            <a:off x="504720" y="6573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1" lang="en-US" sz="12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43" name="Text Box 2"/>
          <p:cNvSpPr/>
          <p:nvPr/>
        </p:nvSpPr>
        <p:spPr>
          <a:xfrm>
            <a:off x="824040" y="2579760"/>
            <a:ext cx="8137440" cy="390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MSKDSTKELSAP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D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ARE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RTKA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IE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AMSQIEK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A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FGKGSIMKLGA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E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SKLDVQ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SV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STGSLSLD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L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LG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I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GIP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R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RVTEIYGPESGGKTTLALSI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V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Q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A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QKAGG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..||   :.||::||||||||.|||||||||||:||||||::||||||||:|||:||||:|||||||||||||||||||||:||:|||||                        </a:t>
            </a:r>
            <a:r>
              <a:rPr b="1" lang="fr-FR" sz="1000" spc="-1" strike="noStrike">
                <a:solidFill>
                  <a:srgbClr val="000000"/>
                </a:solidFill>
                <a:latin typeface="Comic Sans MS"/>
                <a:ea typeface="Courier New"/>
              </a:rPr>
              <a:t>         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mic Sans MS"/>
                <a:ea typeface="Courier New"/>
              </a:rPr>
              <a:t>              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MD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D---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QH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KA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LQ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AMSQIEK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Q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FGKGSIMKLGA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D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SKLDVQ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AI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STGSLSLD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V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LG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V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GIP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K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RVTEIYGPESGGKTTLALSI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I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Q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S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QKAGG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CAFIDAEHALDPVYARALGVNTD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E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LLVSQPDNGEQALEIMELL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V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RSGAIDVVVVDSVAALTPRAEIEGEMGDSLPGLQARLMSQALRKLT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A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L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SKTGTA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||||||||||||||||||||||||:|||||||||||||||||||:||||||||||||||||||||||||||||||||||||||||||||||:|:||||||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TCAFIDAEHALDPVYARALGVNTD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D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LLVSQPDNGEQALEIMELL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I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RSGAIDVVVVDSVAALTPRAEIEGEMGDSLPGLQARLMSQALRKLT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S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V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SKTGTA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IFINQVREKIGVMYGNPETTTGG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R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LKFYASVRLDVRK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I-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QPVKLG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D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V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GNT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VKVK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S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VKNKVAPPFKEVELTL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M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YG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K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FD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QLS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DLVTLA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SDMDI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KK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||||||||||||||||||||||||:||||||||||||||: |:...:.|.||.::||||:||||||||||||||||.||.|||.:.||||||:..::|||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IFINQVREKIGVMYGNPETTTGG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K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LKFYASVRLDVRK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MG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KSTMVD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N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V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V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SHS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VKVK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T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VKNKVAPPFKEVELTL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R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YG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H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FD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AMD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DLVTLA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TTFEV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KK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GSFYSYGDERIGQGKEKAIA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YIA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ERP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EMEQE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R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D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RVL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NAI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RG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GASEQPTK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AL</a:t>
            </a:r>
            <a:r>
              <a:rPr b="1" lang="fr-FR" sz="1000" spc="-1" strike="noStrike">
                <a:solidFill>
                  <a:srgbClr val="0000ff"/>
                </a:solidFill>
                <a:latin typeface="Courier New"/>
                <a:ea typeface="Courier New"/>
              </a:rPr>
              <a:t>AE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|||||||||||||||||||||:::|||::..:||:|||..:||.......:|||:.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GSFYSYGDERIGQGKEKAIA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FLS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ERP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DLLAD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IR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E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RVL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AQM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RG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TPVAPLPE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PAL</a:t>
            </a:r>
            <a:r>
              <a:rPr b="1" lang="fr-FR" sz="1000" spc="-1" strike="noStrike">
                <a:solidFill>
                  <a:srgbClr val="ff0000"/>
                </a:solidFill>
                <a:latin typeface="Courier New"/>
                <a:ea typeface="Courier New"/>
              </a:rPr>
              <a:t>SAD</a:t>
            </a:r>
            <a:r>
              <a:rPr b="1" lang="fr-FR" sz="1000" spc="-1" strike="noStrike">
                <a:solidFill>
                  <a:srgbClr val="000000"/>
                </a:solidFill>
                <a:latin typeface="Courier New"/>
              </a:rPr>
              <a:t> 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 </a:t>
            </a: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44" name="Line 5"/>
          <p:cNvSpPr/>
          <p:nvPr/>
        </p:nvSpPr>
        <p:spPr>
          <a:xfrm>
            <a:off x="3887640" y="4761000"/>
            <a:ext cx="147636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45" name="Line 6"/>
          <p:cNvSpPr/>
          <p:nvPr/>
        </p:nvSpPr>
        <p:spPr>
          <a:xfrm>
            <a:off x="7667640" y="3537000"/>
            <a:ext cx="541440" cy="0"/>
          </a:xfrm>
          <a:prstGeom prst="line">
            <a:avLst/>
          </a:prstGeom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46" name="Line 7"/>
          <p:cNvSpPr/>
          <p:nvPr/>
        </p:nvSpPr>
        <p:spPr>
          <a:xfrm>
            <a:off x="900000" y="2781360"/>
            <a:ext cx="5327640" cy="0"/>
          </a:xfrm>
          <a:prstGeom prst="line">
            <a:avLst/>
          </a:prstGeom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47" name="Line 8"/>
          <p:cNvSpPr/>
          <p:nvPr/>
        </p:nvSpPr>
        <p:spPr>
          <a:xfrm>
            <a:off x="1692360" y="3068640"/>
            <a:ext cx="417492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48" name="Line 9"/>
          <p:cNvSpPr/>
          <p:nvPr/>
        </p:nvSpPr>
        <p:spPr>
          <a:xfrm>
            <a:off x="2303640" y="5697360"/>
            <a:ext cx="291600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49" name="Line 10"/>
          <p:cNvSpPr/>
          <p:nvPr/>
        </p:nvSpPr>
        <p:spPr>
          <a:xfrm flipV="1">
            <a:off x="2195640" y="3537000"/>
            <a:ext cx="2197080" cy="25200"/>
          </a:xfrm>
          <a:prstGeom prst="line">
            <a:avLst/>
          </a:prstGeom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600" bIns="-216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0" name="Line 11"/>
          <p:cNvSpPr/>
          <p:nvPr/>
        </p:nvSpPr>
        <p:spPr>
          <a:xfrm>
            <a:off x="1727280" y="4473720"/>
            <a:ext cx="1044360" cy="0"/>
          </a:xfrm>
          <a:prstGeom prst="line">
            <a:avLst/>
          </a:prstGeom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1" name="Line 12"/>
          <p:cNvSpPr/>
          <p:nvPr/>
        </p:nvSpPr>
        <p:spPr>
          <a:xfrm>
            <a:off x="6264360" y="4761000"/>
            <a:ext cx="219528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2" name="Line 13"/>
          <p:cNvSpPr/>
          <p:nvPr/>
        </p:nvSpPr>
        <p:spPr>
          <a:xfrm>
            <a:off x="1763640" y="4761000"/>
            <a:ext cx="104472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3" name="Line 14"/>
          <p:cNvSpPr/>
          <p:nvPr/>
        </p:nvSpPr>
        <p:spPr>
          <a:xfrm>
            <a:off x="7308720" y="2781360"/>
            <a:ext cx="978120" cy="0"/>
          </a:xfrm>
          <a:prstGeom prst="line">
            <a:avLst/>
          </a:prstGeom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4" name="Line 15"/>
          <p:cNvSpPr/>
          <p:nvPr/>
        </p:nvSpPr>
        <p:spPr>
          <a:xfrm>
            <a:off x="7308720" y="3068640"/>
            <a:ext cx="99072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5" name="Line 16"/>
          <p:cNvSpPr/>
          <p:nvPr/>
        </p:nvSpPr>
        <p:spPr>
          <a:xfrm>
            <a:off x="7704000" y="3860640"/>
            <a:ext cx="50508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6" name="Line 17"/>
          <p:cNvSpPr/>
          <p:nvPr/>
        </p:nvSpPr>
        <p:spPr>
          <a:xfrm>
            <a:off x="2232000" y="3860640"/>
            <a:ext cx="2195640" cy="0"/>
          </a:xfrm>
          <a:prstGeom prst="line">
            <a:avLst/>
          </a:prstGeom>
          <a:ln w="2844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7" name="Text Box 13"/>
          <p:cNvSpPr/>
          <p:nvPr/>
        </p:nvSpPr>
        <p:spPr>
          <a:xfrm>
            <a:off x="469800" y="263700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1" lang="en-US" sz="12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8" name="Line 11"/>
          <p:cNvSpPr/>
          <p:nvPr/>
        </p:nvSpPr>
        <p:spPr>
          <a:xfrm>
            <a:off x="3924360" y="4473720"/>
            <a:ext cx="1476360" cy="0"/>
          </a:xfrm>
          <a:prstGeom prst="line">
            <a:avLst/>
          </a:prstGeom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59" name="Line 11"/>
          <p:cNvSpPr/>
          <p:nvPr/>
        </p:nvSpPr>
        <p:spPr>
          <a:xfrm>
            <a:off x="6264360" y="4473720"/>
            <a:ext cx="2195280" cy="0"/>
          </a:xfrm>
          <a:prstGeom prst="line">
            <a:avLst/>
          </a:prstGeom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60" name="Line 11"/>
          <p:cNvSpPr/>
          <p:nvPr/>
        </p:nvSpPr>
        <p:spPr>
          <a:xfrm>
            <a:off x="2303640" y="5373720"/>
            <a:ext cx="2844720" cy="0"/>
          </a:xfrm>
          <a:prstGeom prst="line">
            <a:avLst/>
          </a:prstGeom>
          <a:ln w="2844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61" name="Text Box 23"/>
          <p:cNvSpPr/>
          <p:nvPr/>
        </p:nvSpPr>
        <p:spPr>
          <a:xfrm>
            <a:off x="647640" y="189000"/>
            <a:ext cx="68436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Comic Sans MS"/>
            </a:endParaRPr>
          </a:p>
        </p:txBody>
      </p:sp>
      <p:sp>
        <p:nvSpPr>
          <p:cNvPr id="62" name="Text Box 24"/>
          <p:cNvSpPr/>
          <p:nvPr/>
        </p:nvSpPr>
        <p:spPr>
          <a:xfrm>
            <a:off x="503280" y="115920"/>
            <a:ext cx="8458200" cy="3427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Figure </a:t>
            </a:r>
            <a:r>
              <a:rPr b="1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3      Comparison between Deide_1p01260 &amp; Deide_3p00210 genes, and RecAc &amp; RecAp polypeptides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  </a:t>
            </a:r>
            <a:endParaRPr b="1" lang="en-US" sz="1200" spc="-1" strike="noStrike">
              <a:solidFill>
                <a:srgbClr val="000000"/>
              </a:solidFill>
              <a:latin typeface="Comic Sans MS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7-07T10:51:23Z</dcterms:created>
  <dc:creator>VALRHO</dc:creator>
  <dc:description/>
  <dc:language>en-US</dc:language>
  <cp:lastModifiedBy>DEDIEU Alain</cp:lastModifiedBy>
  <dcterms:modified xsi:type="dcterms:W3CDTF">2012-07-26T13:26:02Z</dcterms:modified>
  <cp:revision>334</cp:revision>
  <dc:subject/>
  <dc:title>Diapositive 1</dc:title>
</cp:coreProperties>
</file>